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0" d="100"/>
          <a:sy n="110" d="100"/>
        </p:scale>
        <p:origin x="343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7879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7006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5205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1787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4633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4441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0475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9757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6568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8394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5649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A2B51C-F854-4329-B7D6-B7B058765E0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AFD54B-FDB0-4B5B-A8AF-A0EDCB7E39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4533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73" t="5720" r="48782" b="10818"/>
          <a:stretch/>
        </p:blipFill>
        <p:spPr>
          <a:xfrm>
            <a:off x="3813581" y="917972"/>
            <a:ext cx="1598803" cy="5691389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5295388" y="4211659"/>
            <a:ext cx="14226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PARC </a:t>
            </a:r>
            <a:endParaRPr lang="de-DE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~40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53" t="12273" r="59681" b="14078"/>
          <a:stretch/>
        </p:blipFill>
        <p:spPr>
          <a:xfrm>
            <a:off x="513804" y="917972"/>
            <a:ext cx="2000137" cy="5694973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439940" y="356442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444424" y="326049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428742" y="245202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424923" y="220033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67402" y="393466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39940" y="440085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67402" y="582157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24923" y="281760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44424" y="479882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066161" y="459879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1519245" y="458320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3813581" y="4127758"/>
            <a:ext cx="1539710" cy="76833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Textfeld 16"/>
          <p:cNvSpPr txBox="1"/>
          <p:nvPr/>
        </p:nvSpPr>
        <p:spPr>
          <a:xfrm>
            <a:off x="3514686" y="311869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514686" y="338968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514686" y="371827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532711" y="412174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513804" y="1817909"/>
            <a:ext cx="1698335" cy="659428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Textfeld 21"/>
          <p:cNvSpPr txBox="1"/>
          <p:nvPr/>
        </p:nvSpPr>
        <p:spPr>
          <a:xfrm>
            <a:off x="2459323" y="1877171"/>
            <a:ext cx="9428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de-DE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~ 240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424923" y="6828410"/>
            <a:ext cx="598745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) Wester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PARC (~40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, CD146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~240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LM-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LMSC-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C. </a:t>
            </a:r>
            <a:endParaRPr lang="de-DE" sz="1200" dirty="0"/>
          </a:p>
        </p:txBody>
      </p:sp>
      <p:sp>
        <p:nvSpPr>
          <p:cNvPr id="24" name="Textfeld 23"/>
          <p:cNvSpPr txBox="1"/>
          <p:nvPr/>
        </p:nvSpPr>
        <p:spPr>
          <a:xfrm>
            <a:off x="4099687" y="469649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4552771" y="468090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22862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2</Words>
  <Application>Microsoft Office PowerPoint</Application>
  <PresentationFormat>A4-Papier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Naresh Polisetti</dc:creator>
  <cp:lastModifiedBy>Dr. Naresh Polisetti</cp:lastModifiedBy>
  <cp:revision>9</cp:revision>
  <dcterms:created xsi:type="dcterms:W3CDTF">2024-02-19T09:59:13Z</dcterms:created>
  <dcterms:modified xsi:type="dcterms:W3CDTF">2024-02-21T11:20:42Z</dcterms:modified>
</cp:coreProperties>
</file>